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88"/>
    <p:restoredTop sz="94732"/>
  </p:normalViewPr>
  <p:slideViewPr>
    <p:cSldViewPr snapToGrid="0" snapToObjects="1" showGuides="1">
      <p:cViewPr varScale="1">
        <p:scale>
          <a:sx n="56" d="100"/>
          <a:sy n="56" d="100"/>
        </p:scale>
        <p:origin x="2896" y="192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6FA1BA-6BB8-E343-B2E4-C4CC25820F6A}" type="datetimeFigureOut">
              <a:rPr lang="en-US" smtClean="0"/>
              <a:t>5/2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C6C8C-9020-1B4A-B797-463579C8ED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970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6FA1BA-6BB8-E343-B2E4-C4CC25820F6A}" type="datetimeFigureOut">
              <a:rPr lang="en-US" smtClean="0"/>
              <a:t>5/2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C6C8C-9020-1B4A-B797-463579C8ED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607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6FA1BA-6BB8-E343-B2E4-C4CC25820F6A}" type="datetimeFigureOut">
              <a:rPr lang="en-US" smtClean="0"/>
              <a:t>5/2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C6C8C-9020-1B4A-B797-463579C8ED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4775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6FA1BA-6BB8-E343-B2E4-C4CC25820F6A}" type="datetimeFigureOut">
              <a:rPr lang="en-US" smtClean="0"/>
              <a:t>5/2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C6C8C-9020-1B4A-B797-463579C8ED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876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6FA1BA-6BB8-E343-B2E4-C4CC25820F6A}" type="datetimeFigureOut">
              <a:rPr lang="en-US" smtClean="0"/>
              <a:t>5/2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C6C8C-9020-1B4A-B797-463579C8ED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2289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6FA1BA-6BB8-E343-B2E4-C4CC25820F6A}" type="datetimeFigureOut">
              <a:rPr lang="en-US" smtClean="0"/>
              <a:t>5/2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C6C8C-9020-1B4A-B797-463579C8ED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838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6FA1BA-6BB8-E343-B2E4-C4CC25820F6A}" type="datetimeFigureOut">
              <a:rPr lang="en-US" smtClean="0"/>
              <a:t>5/29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C6C8C-9020-1B4A-B797-463579C8ED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64595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6FA1BA-6BB8-E343-B2E4-C4CC25820F6A}" type="datetimeFigureOut">
              <a:rPr lang="en-US" smtClean="0"/>
              <a:t>5/29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C6C8C-9020-1B4A-B797-463579C8ED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081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6FA1BA-6BB8-E343-B2E4-C4CC25820F6A}" type="datetimeFigureOut">
              <a:rPr lang="en-US" smtClean="0"/>
              <a:t>5/29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C6C8C-9020-1B4A-B797-463579C8ED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9243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6FA1BA-6BB8-E343-B2E4-C4CC25820F6A}" type="datetimeFigureOut">
              <a:rPr lang="en-US" smtClean="0"/>
              <a:t>5/2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C6C8C-9020-1B4A-B797-463579C8ED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95422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6FA1BA-6BB8-E343-B2E4-C4CC25820F6A}" type="datetimeFigureOut">
              <a:rPr lang="en-US" smtClean="0"/>
              <a:t>5/2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C6C8C-9020-1B4A-B797-463579C8ED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24721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6FA1BA-6BB8-E343-B2E4-C4CC25820F6A}" type="datetimeFigureOut">
              <a:rPr lang="en-US" smtClean="0"/>
              <a:t>5/2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EC6C8C-9020-1B4A-B797-463579C8ED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969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picture containing white&#10;&#10;Description automatically generated">
            <a:extLst>
              <a:ext uri="{FF2B5EF4-FFF2-40B4-BE49-F238E27FC236}">
                <a16:creationId xmlns:a16="http://schemas.microsoft.com/office/drawing/2014/main" id="{9B7A3D4B-A404-5347-8E0B-B8C9EECA11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5800" y="646771"/>
            <a:ext cx="6400800" cy="6400800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0AEF919F-8E51-D249-8090-B5BE06728BE2}"/>
              </a:ext>
            </a:extLst>
          </p:cNvPr>
          <p:cNvSpPr/>
          <p:nvPr/>
        </p:nvSpPr>
        <p:spPr>
          <a:xfrm>
            <a:off x="685800" y="7237786"/>
            <a:ext cx="64008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</a:t>
            </a:r>
            <a:r>
              <a:rPr lang="en-US" b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ure S1.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ummary heatmap from HAPPI GWAS demo data illustrating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ignificant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NP distribution across chromosomes and all traits. The x-axis shows only chromosomes containing significant SNPs; the y-axis shows all traits with significant SNP-trait associations. Rectangles represent SNPs that are color-coded based on P-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value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904615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50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nne Emery</dc:creator>
  <cp:lastModifiedBy>Marianne Emery</cp:lastModifiedBy>
  <cp:revision>7</cp:revision>
  <dcterms:created xsi:type="dcterms:W3CDTF">2020-02-06T20:09:24Z</dcterms:created>
  <dcterms:modified xsi:type="dcterms:W3CDTF">2020-05-29T17:38:01Z</dcterms:modified>
</cp:coreProperties>
</file>